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2" r:id="rId3"/>
    <p:sldId id="266" r:id="rId4"/>
    <p:sldId id="263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0236902-0CCD-11F5-246E-352ABFBB20BA}" name="Joost van den Aardweg" initials="Jv" userId="308536c1d9c7c51b" providerId="Windows Live"/>
  <p188:author id="{C9AB0A61-4DE9-BFDC-A41D-E81F522F42A2}" name="Aardweg, J.G. van den (Joost)" initials="AJvd(" userId="S::j.g.vandenaardweg@amsterdamumc.nl::e3ddb58a-1019-4e0f-8f43-691f21920af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6" d="100"/>
          <a:sy n="46" d="100"/>
        </p:scale>
        <p:origin x="2104" y="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19281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8188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50465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82588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42909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9038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76120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14075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22754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2041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63731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307C9-1593-4A26-BB81-A083F7B9FC7C}" type="datetimeFigureOut">
              <a:rPr lang="nl-NL" smtClean="0"/>
              <a:t>1-7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1FF80-307C-4BB8-A9AC-C0D355302A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79075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z="1800" b="1" kern="1400" spc="25" dirty="0">
                <a:solidFill>
                  <a:srgbClr val="17365D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 of Trimetazidine Dihydrochloride Therapy on Myocardial External Efficiency in Preclinical Individuals With a Hypertrophic Cardiomyopathy Pathogenic Variant: results of the ENERGY trial</a:t>
            </a:r>
            <a:br>
              <a:rPr lang="en-US" sz="1800" b="1" kern="1400" spc="25" dirty="0">
                <a:solidFill>
                  <a:srgbClr val="17365D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800" b="1" kern="1400" spc="25" dirty="0">
                <a:solidFill>
                  <a:srgbClr val="17365D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Randomized Clinical Trial</a:t>
            </a:r>
            <a:br>
              <a:rPr lang="nl-NL" sz="1800" kern="1400" spc="25" dirty="0">
                <a:solidFill>
                  <a:srgbClr val="17365D"/>
                </a:solidFill>
                <a:effectLst/>
                <a:latin typeface="Cambria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s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01446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/>
          <p:cNvSpPr txBox="1"/>
          <p:nvPr/>
        </p:nvSpPr>
        <p:spPr>
          <a:xfrm>
            <a:off x="0" y="29244"/>
            <a:ext cx="135165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13" dirty="0"/>
              <a:t>Supplemental </a:t>
            </a:r>
            <a:r>
              <a:rPr lang="nl-NL" sz="1013" dirty="0" err="1"/>
              <a:t>figure</a:t>
            </a:r>
            <a:r>
              <a:rPr lang="nl-NL" sz="1013" dirty="0"/>
              <a:t> 1</a:t>
            </a:r>
          </a:p>
        </p:txBody>
      </p:sp>
      <p:pic>
        <p:nvPicPr>
          <p:cNvPr id="5" name="Afbeelding 4"/>
          <p:cNvPicPr>
            <a:picLocks noChangeAspect="1"/>
          </p:cNvPicPr>
          <p:nvPr/>
        </p:nvPicPr>
        <p:blipFill rotWithShape="1">
          <a:blip r:embed="rId2"/>
          <a:srcRect r="29053"/>
          <a:stretch/>
        </p:blipFill>
        <p:spPr>
          <a:xfrm>
            <a:off x="56229" y="277453"/>
            <a:ext cx="2702260" cy="3240000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 rotWithShape="1">
          <a:blip r:embed="rId3"/>
          <a:srcRect r="29699"/>
          <a:stretch/>
        </p:blipFill>
        <p:spPr>
          <a:xfrm>
            <a:off x="2701718" y="292201"/>
            <a:ext cx="2608116" cy="3240000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 rotWithShape="1">
          <a:blip r:embed="rId4"/>
          <a:srcRect r="33472"/>
          <a:stretch/>
        </p:blipFill>
        <p:spPr>
          <a:xfrm>
            <a:off x="131300" y="3386137"/>
            <a:ext cx="2440704" cy="3240000"/>
          </a:xfrm>
          <a:prstGeom prst="rect">
            <a:avLst/>
          </a:prstGeom>
        </p:spPr>
      </p:pic>
      <p:pic>
        <p:nvPicPr>
          <p:cNvPr id="8" name="Afbeelding 7"/>
          <p:cNvPicPr>
            <a:picLocks noChangeAspect="1"/>
          </p:cNvPicPr>
          <p:nvPr/>
        </p:nvPicPr>
        <p:blipFill rotWithShape="1">
          <a:blip r:embed="rId5"/>
          <a:srcRect r="31004"/>
          <a:stretch/>
        </p:blipFill>
        <p:spPr>
          <a:xfrm>
            <a:off x="2728993" y="3400885"/>
            <a:ext cx="2457326" cy="3240000"/>
          </a:xfrm>
          <a:prstGeom prst="rect">
            <a:avLst/>
          </a:prstGeom>
        </p:spPr>
      </p:pic>
      <p:pic>
        <p:nvPicPr>
          <p:cNvPr id="9" name="Afbeelding 8"/>
          <p:cNvPicPr>
            <a:picLocks noChangeAspect="1"/>
          </p:cNvPicPr>
          <p:nvPr/>
        </p:nvPicPr>
        <p:blipFill rotWithShape="1">
          <a:blip r:embed="rId5"/>
          <a:srcRect l="68817" t="11389" b="73246"/>
          <a:stretch/>
        </p:blipFill>
        <p:spPr>
          <a:xfrm>
            <a:off x="5515896" y="383458"/>
            <a:ext cx="1283110" cy="575187"/>
          </a:xfrm>
          <a:prstGeom prst="rect">
            <a:avLst/>
          </a:prstGeom>
        </p:spPr>
      </p:pic>
      <p:sp>
        <p:nvSpPr>
          <p:cNvPr id="2" name="Rechthoek 1">
            <a:extLst>
              <a:ext uri="{FF2B5EF4-FFF2-40B4-BE49-F238E27FC236}">
                <a16:creationId xmlns:a16="http://schemas.microsoft.com/office/drawing/2014/main" id="{7C86ECF4-816C-831F-E75D-0BD8D2138DB0}"/>
              </a:ext>
            </a:extLst>
          </p:cNvPr>
          <p:cNvSpPr/>
          <p:nvPr/>
        </p:nvSpPr>
        <p:spPr>
          <a:xfrm>
            <a:off x="56229" y="6640885"/>
            <a:ext cx="673618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563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aseline LV end-diastolic volume, LV systolic volume, LV stroke volume, and LV mass in the placebo (n=20) and TMZ (n=20) groups, from top left to bottom right, respectively. Tukey boxplots show median and spread. Subjects with a P/LP variant in the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BPC3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H7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are depicted by circles and triangles, respectively.</a:t>
            </a:r>
            <a:endParaRPr lang="nl-NL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85493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>
            <a:extLst>
              <a:ext uri="{FF2B5EF4-FFF2-40B4-BE49-F238E27FC236}">
                <a16:creationId xmlns:a16="http://schemas.microsoft.com/office/drawing/2014/main" id="{88A7ABF1-072D-044F-88F7-AF31CD48E33D}"/>
              </a:ext>
            </a:extLst>
          </p:cNvPr>
          <p:cNvSpPr txBox="1"/>
          <p:nvPr/>
        </p:nvSpPr>
        <p:spPr>
          <a:xfrm>
            <a:off x="0" y="29244"/>
            <a:ext cx="135165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13" dirty="0"/>
              <a:t>Supplemental </a:t>
            </a:r>
            <a:r>
              <a:rPr lang="nl-NL" sz="1013" dirty="0" err="1"/>
              <a:t>figure</a:t>
            </a:r>
            <a:r>
              <a:rPr lang="nl-NL" sz="1013" dirty="0"/>
              <a:t> 2</a:t>
            </a:r>
          </a:p>
        </p:txBody>
      </p:sp>
      <p:pic>
        <p:nvPicPr>
          <p:cNvPr id="5" name="Afbeelding 4">
            <a:extLst>
              <a:ext uri="{FF2B5EF4-FFF2-40B4-BE49-F238E27FC236}">
                <a16:creationId xmlns:a16="http://schemas.microsoft.com/office/drawing/2014/main" id="{FC4C4D02-BFC2-D589-7FE1-812FA7F124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0005" t="17634" r="2345" b="49632"/>
          <a:stretch/>
        </p:blipFill>
        <p:spPr>
          <a:xfrm>
            <a:off x="5455723" y="212124"/>
            <a:ext cx="970015" cy="1015663"/>
          </a:xfrm>
          <a:prstGeom prst="rect">
            <a:avLst/>
          </a:prstGeom>
        </p:spPr>
      </p:pic>
      <p:pic>
        <p:nvPicPr>
          <p:cNvPr id="7" name="Afbeelding 6">
            <a:extLst>
              <a:ext uri="{FF2B5EF4-FFF2-40B4-BE49-F238E27FC236}">
                <a16:creationId xmlns:a16="http://schemas.microsoft.com/office/drawing/2014/main" id="{D73E349F-3123-7EA4-B15A-ED2AA9B14A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36" r="24098"/>
          <a:stretch/>
        </p:blipFill>
        <p:spPr>
          <a:xfrm>
            <a:off x="-117712" y="3219119"/>
            <a:ext cx="3546711" cy="3636597"/>
          </a:xfrm>
          <a:prstGeom prst="rect">
            <a:avLst/>
          </a:prstGeom>
        </p:spPr>
      </p:pic>
      <p:pic>
        <p:nvPicPr>
          <p:cNvPr id="8" name="Afbeelding 7">
            <a:extLst>
              <a:ext uri="{FF2B5EF4-FFF2-40B4-BE49-F238E27FC236}">
                <a16:creationId xmlns:a16="http://schemas.microsoft.com/office/drawing/2014/main" id="{2833E5E7-95B2-231F-CC71-D5AD9B0E4F8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25212"/>
          <a:stretch/>
        </p:blipFill>
        <p:spPr>
          <a:xfrm>
            <a:off x="3404420" y="3280210"/>
            <a:ext cx="3354749" cy="3558390"/>
          </a:xfrm>
          <a:prstGeom prst="rect">
            <a:avLst/>
          </a:prstGeom>
        </p:spPr>
      </p:pic>
      <p:pic>
        <p:nvPicPr>
          <p:cNvPr id="10" name="Afbeelding 9">
            <a:extLst>
              <a:ext uri="{FF2B5EF4-FFF2-40B4-BE49-F238E27FC236}">
                <a16:creationId xmlns:a16="http://schemas.microsoft.com/office/drawing/2014/main" id="{453758C0-1EE1-71CD-724D-3BA78E84AE62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30087"/>
          <a:stretch/>
        </p:blipFill>
        <p:spPr>
          <a:xfrm>
            <a:off x="1918681" y="79122"/>
            <a:ext cx="3020637" cy="3345723"/>
          </a:xfrm>
          <a:prstGeom prst="rect">
            <a:avLst/>
          </a:prstGeom>
        </p:spPr>
      </p:pic>
      <p:sp>
        <p:nvSpPr>
          <p:cNvPr id="11" name="Rechthoek 10">
            <a:extLst>
              <a:ext uri="{FF2B5EF4-FFF2-40B4-BE49-F238E27FC236}">
                <a16:creationId xmlns:a16="http://schemas.microsoft.com/office/drawing/2014/main" id="{007E9C02-90B3-3719-07E4-E399DFFB98C8}"/>
              </a:ext>
            </a:extLst>
          </p:cNvPr>
          <p:cNvSpPr/>
          <p:nvPr/>
        </p:nvSpPr>
        <p:spPr>
          <a:xfrm>
            <a:off x="8313" y="6844756"/>
            <a:ext cx="6736180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563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p: Baseline myocardial external efficiency in participants &lt;40 years old (n=12) and participants &gt;40 years old (n=28). </a:t>
            </a:r>
          </a:p>
          <a:p>
            <a:pPr>
              <a:spcAft>
                <a:spcPts val="563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ttom left: baseline and follow-up myocardial external efficiency in participants &lt;40 years old in the placebo (n=6) and TMZ (n=6) groups. Bottom right: baseline and follow-up myocardial external efficiency in participants &gt;40 years old in the placebo (n=14) and TMZ (n=14) groups.</a:t>
            </a:r>
          </a:p>
          <a:p>
            <a:pPr>
              <a:spcAft>
                <a:spcPts val="563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seline and follow-up values of individual subjects are connected by a line. Tukey boxplots show median and spread, with numerical values for mean and standard deviation below. Subjects with a P/LP variant in the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BPC3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H7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are depicted by circles and triangles, respectively. Baseline values are white, follow-up values are blue. The dotted horizontal line shows mean MEE of healthy controls, as reported previously [12]. Statistical significance was determined by mixed model analysis.</a:t>
            </a:r>
            <a:endParaRPr lang="nl-NL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3278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/>
          <p:cNvSpPr txBox="1"/>
          <p:nvPr/>
        </p:nvSpPr>
        <p:spPr>
          <a:xfrm>
            <a:off x="0" y="29244"/>
            <a:ext cx="135165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13" dirty="0"/>
              <a:t>Supplemental </a:t>
            </a:r>
            <a:r>
              <a:rPr lang="nl-NL" sz="1013" dirty="0" err="1"/>
              <a:t>figure</a:t>
            </a:r>
            <a:r>
              <a:rPr lang="nl-NL" sz="1013" dirty="0"/>
              <a:t> 3</a:t>
            </a:r>
          </a:p>
        </p:txBody>
      </p:sp>
      <p:pic>
        <p:nvPicPr>
          <p:cNvPr id="5" name="Afbeelding 4">
            <a:extLst>
              <a:ext uri="{FF2B5EF4-FFF2-40B4-BE49-F238E27FC236}">
                <a16:creationId xmlns:a16="http://schemas.microsoft.com/office/drawing/2014/main" id="{D8F2BB29-18D1-1465-ECE6-1EA4F01CF4C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" r="30160"/>
          <a:stretch/>
        </p:blipFill>
        <p:spPr>
          <a:xfrm>
            <a:off x="4599072" y="3526688"/>
            <a:ext cx="1969971" cy="2520000"/>
          </a:xfrm>
          <a:prstGeom prst="rect">
            <a:avLst/>
          </a:prstGeom>
        </p:spPr>
      </p:pic>
      <p:pic>
        <p:nvPicPr>
          <p:cNvPr id="7" name="Afbeelding 6">
            <a:extLst>
              <a:ext uri="{FF2B5EF4-FFF2-40B4-BE49-F238E27FC236}">
                <a16:creationId xmlns:a16="http://schemas.microsoft.com/office/drawing/2014/main" id="{763E4A42-3F51-B5D1-8C9D-BFBA6BF090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00" r="30777"/>
          <a:stretch/>
        </p:blipFill>
        <p:spPr>
          <a:xfrm>
            <a:off x="2344407" y="3532181"/>
            <a:ext cx="1986193" cy="2520000"/>
          </a:xfrm>
          <a:prstGeom prst="rect">
            <a:avLst/>
          </a:prstGeom>
        </p:spPr>
      </p:pic>
      <p:pic>
        <p:nvPicPr>
          <p:cNvPr id="9" name="Afbeelding 8">
            <a:extLst>
              <a:ext uri="{FF2B5EF4-FFF2-40B4-BE49-F238E27FC236}">
                <a16:creationId xmlns:a16="http://schemas.microsoft.com/office/drawing/2014/main" id="{3BAD858A-9773-7079-D8C6-DCE61DF66EB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6" r="28009"/>
          <a:stretch/>
        </p:blipFill>
        <p:spPr>
          <a:xfrm>
            <a:off x="4484964" y="1037991"/>
            <a:ext cx="2038760" cy="2520000"/>
          </a:xfrm>
          <a:prstGeom prst="rect">
            <a:avLst/>
          </a:prstGeom>
        </p:spPr>
      </p:pic>
      <p:pic>
        <p:nvPicPr>
          <p:cNvPr id="13" name="Afbeelding 12">
            <a:extLst>
              <a:ext uri="{FF2B5EF4-FFF2-40B4-BE49-F238E27FC236}">
                <a16:creationId xmlns:a16="http://schemas.microsoft.com/office/drawing/2014/main" id="{4E0FEAF7-5A03-23BC-F7A5-25960C4B803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1" r="25865"/>
          <a:stretch/>
        </p:blipFill>
        <p:spPr>
          <a:xfrm>
            <a:off x="31650" y="3497428"/>
            <a:ext cx="2251303" cy="2520000"/>
          </a:xfrm>
          <a:prstGeom prst="rect">
            <a:avLst/>
          </a:prstGeom>
        </p:spPr>
      </p:pic>
      <p:pic>
        <p:nvPicPr>
          <p:cNvPr id="15" name="Afbeelding 14">
            <a:extLst>
              <a:ext uri="{FF2B5EF4-FFF2-40B4-BE49-F238E27FC236}">
                <a16:creationId xmlns:a16="http://schemas.microsoft.com/office/drawing/2014/main" id="{5C423ED7-68A8-3D9D-220A-7FF69AC5FA1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" r="25344"/>
          <a:stretch/>
        </p:blipFill>
        <p:spPr>
          <a:xfrm>
            <a:off x="-692" y="1030728"/>
            <a:ext cx="2406701" cy="2520000"/>
          </a:xfrm>
          <a:prstGeom prst="rect">
            <a:avLst/>
          </a:prstGeom>
        </p:spPr>
      </p:pic>
      <p:pic>
        <p:nvPicPr>
          <p:cNvPr id="17" name="Afbeelding 16">
            <a:extLst>
              <a:ext uri="{FF2B5EF4-FFF2-40B4-BE49-F238E27FC236}">
                <a16:creationId xmlns:a16="http://schemas.microsoft.com/office/drawing/2014/main" id="{04445DAE-81F5-D11E-A6F8-5643AE4E034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7" r="30958"/>
          <a:stretch/>
        </p:blipFill>
        <p:spPr>
          <a:xfrm>
            <a:off x="2399380" y="1036408"/>
            <a:ext cx="2038760" cy="2520000"/>
          </a:xfrm>
          <a:prstGeom prst="rect">
            <a:avLst/>
          </a:prstGeom>
        </p:spPr>
      </p:pic>
      <p:sp>
        <p:nvSpPr>
          <p:cNvPr id="18" name="Rechthoek 17">
            <a:extLst>
              <a:ext uri="{FF2B5EF4-FFF2-40B4-BE49-F238E27FC236}">
                <a16:creationId xmlns:a16="http://schemas.microsoft.com/office/drawing/2014/main" id="{E0767E29-E23F-149F-E93A-82D9EDD3406D}"/>
              </a:ext>
            </a:extLst>
          </p:cNvPr>
          <p:cNvSpPr/>
          <p:nvPr/>
        </p:nvSpPr>
        <p:spPr>
          <a:xfrm>
            <a:off x="60910" y="6033693"/>
            <a:ext cx="673618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563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aseline and follow-up work rate at anaerobic threshold, maximum work rate, time to max work, VO</a:t>
            </a:r>
            <a:r>
              <a:rPr lang="en-US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uring unloaded pedaling, O</a:t>
            </a:r>
            <a:r>
              <a:rPr lang="en-US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ulse, and delta VO</a:t>
            </a:r>
            <a:r>
              <a:rPr lang="en-US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delta work rate in the placebo (n=20) and TMZ (n=20) groups, from top left to bottom right, respectively. Baseline and follow-up values of individual subjects are connected by a line. Tukey boxplots show median and spread. Subjects with a P/LP variant in the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BPC3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H7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are depicted by circles and triangles, respectively. Baseline values are white, follow-up values are blue. Statistical significance was determined by mixed model analysis, multiple comparisons were corrected using statistical hypothesis testing with the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Šídák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ethod.</a:t>
            </a:r>
            <a:endParaRPr lang="nl-NL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Afbeelding 2">
            <a:extLst>
              <a:ext uri="{FF2B5EF4-FFF2-40B4-BE49-F238E27FC236}">
                <a16:creationId xmlns:a16="http://schemas.microsoft.com/office/drawing/2014/main" id="{7782762D-39B3-DC8E-FD65-0F2FF97C1D7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0005" t="17634" r="2345" b="49632"/>
          <a:stretch/>
        </p:blipFill>
        <p:spPr>
          <a:xfrm>
            <a:off x="5887985" y="43098"/>
            <a:ext cx="970015" cy="10156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796265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34</Words>
  <Application>Microsoft Office PowerPoint</Application>
  <PresentationFormat>On-screen Show (4:3)</PresentationFormat>
  <Paragraphs>1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ambria</vt:lpstr>
      <vt:lpstr>Times New Roman</vt:lpstr>
      <vt:lpstr>Kantoorthema</vt:lpstr>
      <vt:lpstr>Effect of Trimetazidine Dihydrochloride Therapy on Myocardial External Efficiency in Preclinical Individuals With a Hypertrophic Cardiomyopathy Pathogenic Variant: results of the ENERGY trial A Randomized Clinical Trial </vt:lpstr>
      <vt:lpstr>PowerPoint Presentation</vt:lpstr>
      <vt:lpstr>PowerPoint Presentation</vt:lpstr>
      <vt:lpstr>PowerPoint Presentation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NERGY paper  figuren en tabellen</dc:title>
  <dc:creator>Driel, B.O. van (Beau)</dc:creator>
  <cp:lastModifiedBy>Sarah Brown</cp:lastModifiedBy>
  <cp:revision>32</cp:revision>
  <dcterms:created xsi:type="dcterms:W3CDTF">2024-02-01T15:33:44Z</dcterms:created>
  <dcterms:modified xsi:type="dcterms:W3CDTF">2025-07-01T15:28:44Z</dcterms:modified>
</cp:coreProperties>
</file>